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0" r:id="rId2"/>
    <p:sldId id="271" r:id="rId3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5170" autoAdjust="0"/>
  </p:normalViewPr>
  <p:slideViewPr>
    <p:cSldViewPr snapToGrid="0">
      <p:cViewPr varScale="1">
        <p:scale>
          <a:sx n="49" d="100"/>
          <a:sy n="49" d="100"/>
        </p:scale>
        <p:origin x="25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8/1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C990A-D8E5-4407-8B0E-0B6F0E118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2666" y="-492879"/>
            <a:ext cx="6477951" cy="1767417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Table 2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Adverse Events in the mRCC cohort regardless of attribution</a:t>
            </a:r>
            <a:endParaRPr lang="en-US" sz="1400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ACB30FD-AB28-4B0D-8174-60325A560DA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87383" y="709340"/>
            <a:ext cx="6059940" cy="7917321"/>
          </a:xfrm>
        </p:spPr>
      </p:pic>
    </p:spTree>
    <p:extLst>
      <p:ext uri="{BB962C8B-B14F-4D97-AF65-F5344CB8AC3E}">
        <p14:creationId xmlns:p14="http://schemas.microsoft.com/office/powerpoint/2010/main" val="1268570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27525-5901-496A-9000-6C0A00B64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791" y="-427564"/>
            <a:ext cx="5915025" cy="1767417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1: All Adverse Events in the mRCC cohort regardless of attribution continued</a:t>
            </a:r>
            <a:endParaRPr lang="en-US" sz="1400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F28D423-52F6-48F2-9F17-BA5EF350112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18791" y="749266"/>
            <a:ext cx="6583520" cy="1314665"/>
          </a:xfrm>
        </p:spPr>
      </p:pic>
    </p:spTree>
    <p:extLst>
      <p:ext uri="{BB962C8B-B14F-4D97-AF65-F5344CB8AC3E}">
        <p14:creationId xmlns:p14="http://schemas.microsoft.com/office/powerpoint/2010/main" val="2630999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49</TotalTime>
  <Words>29</Words>
  <Application>Microsoft Office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 Table 2: All Adverse Events in the mRCC cohort regardless of attribution</vt:lpstr>
      <vt:lpstr>Supplement Table 1: All Adverse Events in the mRCC cohort regardless of attribution continue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5</cp:revision>
  <dcterms:created xsi:type="dcterms:W3CDTF">2023-03-30T22:39:16Z</dcterms:created>
  <dcterms:modified xsi:type="dcterms:W3CDTF">2024-08-15T22:22:59Z</dcterms:modified>
</cp:coreProperties>
</file>